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3150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967944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398629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77608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056006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224812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765024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8882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9711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43936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95701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62484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9DBA35-C803-409F-BB36-B91EE33C9E73}" type="datetimeFigureOut">
              <a:rPr lang="es-AR" smtClean="0"/>
              <a:t>11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24005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96AB1E4-CB6C-FA3B-C226-BDFBC14E4342}"/>
              </a:ext>
            </a:extLst>
          </p:cNvPr>
          <p:cNvSpPr txBox="1"/>
          <p:nvPr/>
        </p:nvSpPr>
        <p:spPr>
          <a:xfrm>
            <a:off x="360116" y="217013"/>
            <a:ext cx="58678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0" dirty="0">
                <a:solidFill>
                  <a:srgbClr val="09090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: </a:t>
            </a:r>
            <a:r>
              <a:rPr lang="en-US" sz="1400" b="0" i="0" dirty="0">
                <a:solidFill>
                  <a:srgbClr val="09090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atistical tests, post-hoc analyses, and significance levels used in each study</a:t>
            </a:r>
            <a:endParaRPr lang="es-A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6747DA4-A540-7D85-18A0-74B82F7C15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210" y="956256"/>
            <a:ext cx="6370786" cy="4504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627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17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University of Florida Academic Health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guirre,Jose I</dc:creator>
  <cp:lastModifiedBy>Aguirre,Jose I</cp:lastModifiedBy>
  <cp:revision>5</cp:revision>
  <dcterms:created xsi:type="dcterms:W3CDTF">2026-03-25T17:28:21Z</dcterms:created>
  <dcterms:modified xsi:type="dcterms:W3CDTF">2026-04-11T16:49:46Z</dcterms:modified>
</cp:coreProperties>
</file>